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  <p:sldId id="263" r:id="rId3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14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F6F9D6-5B7D-4737-8582-EE2642E18235}" type="datetimeFigureOut">
              <a:rPr lang="ko-KR" altLang="en-US" smtClean="0"/>
              <a:t>2021-02-0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F4571B-3551-40C0-A535-DD4A95FA11D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0297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F6F9D6-5B7D-4737-8582-EE2642E18235}" type="datetimeFigureOut">
              <a:rPr lang="ko-KR" altLang="en-US" smtClean="0"/>
              <a:t>2021-02-0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F4571B-3551-40C0-A535-DD4A95FA11D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509372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F6F9D6-5B7D-4737-8582-EE2642E18235}" type="datetimeFigureOut">
              <a:rPr lang="ko-KR" altLang="en-US" smtClean="0"/>
              <a:t>2021-02-0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F4571B-3551-40C0-A535-DD4A95FA11D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610891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F6F9D6-5B7D-4737-8582-EE2642E18235}" type="datetimeFigureOut">
              <a:rPr lang="ko-KR" altLang="en-US" smtClean="0"/>
              <a:t>2021-02-0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F4571B-3551-40C0-A535-DD4A95FA11D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14346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F6F9D6-5B7D-4737-8582-EE2642E18235}" type="datetimeFigureOut">
              <a:rPr lang="ko-KR" altLang="en-US" smtClean="0"/>
              <a:t>2021-02-0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F4571B-3551-40C0-A535-DD4A95FA11D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088721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F6F9D6-5B7D-4737-8582-EE2642E18235}" type="datetimeFigureOut">
              <a:rPr lang="ko-KR" altLang="en-US" smtClean="0"/>
              <a:t>2021-02-0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F4571B-3551-40C0-A535-DD4A95FA11D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770655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F6F9D6-5B7D-4737-8582-EE2642E18235}" type="datetimeFigureOut">
              <a:rPr lang="ko-KR" altLang="en-US" smtClean="0"/>
              <a:t>2021-02-08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F4571B-3551-40C0-A535-DD4A95FA11D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602491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F6F9D6-5B7D-4737-8582-EE2642E18235}" type="datetimeFigureOut">
              <a:rPr lang="ko-KR" altLang="en-US" smtClean="0"/>
              <a:t>2021-02-08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F4571B-3551-40C0-A535-DD4A95FA11D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126988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F6F9D6-5B7D-4737-8582-EE2642E18235}" type="datetimeFigureOut">
              <a:rPr lang="ko-KR" altLang="en-US" smtClean="0"/>
              <a:t>2021-02-08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F4571B-3551-40C0-A535-DD4A95FA11D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489764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F6F9D6-5B7D-4737-8582-EE2642E18235}" type="datetimeFigureOut">
              <a:rPr lang="ko-KR" altLang="en-US" smtClean="0"/>
              <a:t>2021-02-0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F4571B-3551-40C0-A535-DD4A95FA11D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85884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F6F9D6-5B7D-4737-8582-EE2642E18235}" type="datetimeFigureOut">
              <a:rPr lang="ko-KR" altLang="en-US" smtClean="0"/>
              <a:t>2021-02-0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F4571B-3551-40C0-A535-DD4A95FA11D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965359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F6F9D6-5B7D-4737-8582-EE2642E18235}" type="datetimeFigureOut">
              <a:rPr lang="ko-KR" altLang="en-US" smtClean="0"/>
              <a:t>2021-02-0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F4571B-3551-40C0-A535-DD4A95FA11D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414504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직사각형 2"/>
          <p:cNvSpPr/>
          <p:nvPr/>
        </p:nvSpPr>
        <p:spPr>
          <a:xfrm>
            <a:off x="1112108" y="5461858"/>
            <a:ext cx="10140778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dirty="0"/>
              <a:t>Figure</a:t>
            </a:r>
            <a:r>
              <a:rPr lang="ko-KR" altLang="en-US" dirty="0"/>
              <a:t> </a:t>
            </a:r>
            <a:r>
              <a:rPr lang="en-US" altLang="ko-KR" dirty="0"/>
              <a:t>S1. Tear</a:t>
            </a:r>
            <a:r>
              <a:rPr lang="ko-KR" altLang="en-US" dirty="0"/>
              <a:t> </a:t>
            </a:r>
            <a:r>
              <a:rPr lang="en-US" altLang="ko-KR" dirty="0"/>
              <a:t>break-up time value in hyaluronic acid (HA) group and non-HA group after excluding the source of publication bias. Non-HA eye drops were classified according to the component: (A) Saline and (B) Artificial tears. SMD: Standardized Mean Difference; CI: Confidence interval.</a:t>
            </a:r>
            <a:endParaRPr lang="ko-KR" altLang="en-US" dirty="0"/>
          </a:p>
        </p:txBody>
      </p:sp>
      <p:pic>
        <p:nvPicPr>
          <p:cNvPr id="5" name="그림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02523" y="345989"/>
            <a:ext cx="5736721" cy="502096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1261975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직사각형 2"/>
          <p:cNvSpPr/>
          <p:nvPr/>
        </p:nvSpPr>
        <p:spPr>
          <a:xfrm>
            <a:off x="1757180" y="4832426"/>
            <a:ext cx="8678725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dirty="0"/>
              <a:t>Figure</a:t>
            </a:r>
            <a:r>
              <a:rPr lang="ko-KR" altLang="en-US" dirty="0"/>
              <a:t> </a:t>
            </a:r>
            <a:r>
              <a:rPr lang="en-US" altLang="ko-KR" dirty="0"/>
              <a:t>S2. Ocular surface disease index value in hyaluronic acid and saline groups using random effect model. SMD: Standardized Mean Difference; CI: Confidence interval.</a:t>
            </a:r>
            <a:endParaRPr lang="ko-KR" altLang="en-US" dirty="0"/>
          </a:p>
        </p:txBody>
      </p:sp>
      <p:pic>
        <p:nvPicPr>
          <p:cNvPr id="7" name="그림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07639" y="332443"/>
            <a:ext cx="6393711" cy="443577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105821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67</TotalTime>
  <Words>87</Words>
  <Application>Microsoft Office PowerPoint</Application>
  <PresentationFormat>Widescreen</PresentationFormat>
  <Paragraphs>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5" baseType="lpstr">
      <vt:lpstr>맑은 고딕</vt:lpstr>
      <vt:lpstr>Arial</vt:lpstr>
      <vt:lpstr>Office 테마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yunjung yang</dc:creator>
  <cp:lastModifiedBy>MDPI</cp:lastModifiedBy>
  <cp:revision>12</cp:revision>
  <dcterms:created xsi:type="dcterms:W3CDTF">2020-12-15T00:47:18Z</dcterms:created>
  <dcterms:modified xsi:type="dcterms:W3CDTF">2021-02-08T06:38:26Z</dcterms:modified>
</cp:coreProperties>
</file>